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23" r:id="rId2"/>
    <p:sldId id="325" r:id="rId3"/>
    <p:sldId id="326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744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45" y="3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62ADB6-C97F-4B04-A815-8F5E1B392321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D5EAF2-6986-42C1-94DD-8CE086D46B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1331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9A292A-559D-DF2A-C7DB-0D7D5A31D0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C937877-E2B6-EB18-A722-9E5EB30835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5A5F8C-E352-8473-D5A1-ACD8E8550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2E5A8F-9DF9-2267-0326-45018310F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3435D2-86A6-5B77-85AF-007255E9E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200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CE06B2-73A8-7124-EE22-B6C183261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9E2E38-5430-B17D-40ED-24941B514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B227DC-0878-AFFC-8046-1100D25A9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41F264-9406-FA76-5114-4DF9ED8DE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778436-C02C-4FD3-6995-67F167149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6582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95DA380-7FC6-3F44-B6EB-572717D6D6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005AB6-98C5-F38D-860D-70315799EF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6782B7-5131-3337-A100-2F9D47149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8A8D29-8F48-A65D-16C6-EF093AD4C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2479A9-B8E9-CB95-EDCF-AE0E89F83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2475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307787-5A14-681D-25F2-50A5D65E8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C820CC-D0DD-C6C6-6F4C-7E3D3BE938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FE1BC5B-2C36-CFBB-751C-B54678623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D0877A-FF53-57F8-A402-6F48EF489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08647C-69E7-F848-BBA2-A6918C3B1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7137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0E0DC1-E619-508F-FF75-17AF09112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8983A7F-2E40-871D-A265-5F27FC6280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77A343-A00B-61CD-3FBD-BDFECC67C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91DBCD-4A7F-2281-3CFD-3FC14588F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219466-2AB8-E18D-0BD8-0BA4A1383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8545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AD7E80-E93F-356D-313C-DE66E6367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B28453-4324-DC51-D510-F7BEC9387F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E0F78DB-2928-033E-32AB-981315326E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3B6A07-F9E9-123D-FC21-F320AAF0A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9F26CB-7F44-A2B3-5F06-D653E8FCE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5DDA3C9-3F24-F4C6-B510-838BC71E3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9537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5DC5AC-0ABD-BB6C-0E55-D68A25336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4FBB5BA-461B-516F-28B5-9AB6883538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1BFF341-1BBB-B240-2479-1B50E3641D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38D812B-A7C2-B889-0299-7B13C17E0D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24DFFC4-7184-53BB-BC2E-8F31BF1330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982E22E-4FEF-2FB0-258F-18C107866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3CD3313-4056-B940-841D-C9D87C2B2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48BD373-A75D-E4C9-539D-79239580B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4551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247CA1-7054-DC96-4176-8355842C8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47964BE-ABB0-5EB0-3D66-5940995F2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182ACA7-FCE2-D53B-90EC-B0B949201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B265A5E-0840-CC73-C435-2BEB378D3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520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1A891B3-313A-E93E-58E9-202F48EB6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B4E9C5E-660A-1246-0248-8F874E591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CFC407B-D50C-E961-377A-1D93EED90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151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CD84FA-63A1-40FF-9C93-9B2895045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FC4EA2-34F0-F420-981C-C4AFFBB889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E07F79E-C794-2A94-B131-CBFB3FD34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230D7F4-2051-67BB-4DAA-A8262ED52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5ED456-5461-1AAA-26D3-489FFFB0D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5A0DEB6-DC7C-03E5-BB63-3A40F13E6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380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F4831C-C432-FB3E-EB38-E2E05A645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5365465-8F95-105D-9389-92CA5E64A3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D5398B1-3387-36F6-456B-4FBA17A16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367398-8AF8-D189-3A85-D90E86F1E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A4664F4-8E33-5FC8-A4CA-642C60B2A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979758-D0F6-4CE4-D0FC-EFA878C64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0246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AF5C73F-EA09-77F0-3877-D9F6AE9ED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30E134-76FB-7835-5493-FEFD51F8B0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8AB464-9C80-333B-632D-8AF0FB3A42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2948A-465C-4DDF-A529-72E4B1D58AEF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7B28D0-EADF-3AE8-F3E3-52872AF62C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852391-24D3-110F-6792-A4BF0C6BED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49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BABF78B2-BC6E-9154-18C1-978C96734FF9}"/>
              </a:ext>
            </a:extLst>
          </p:cNvPr>
          <p:cNvSpPr txBox="1"/>
          <p:nvPr/>
        </p:nvSpPr>
        <p:spPr>
          <a:xfrm>
            <a:off x="2570802" y="3871947"/>
            <a:ext cx="511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>
                <a:solidFill>
                  <a:prstClr val="white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Rectangle 7">
            <a:extLst>
              <a:ext uri="{FF2B5EF4-FFF2-40B4-BE49-F238E27FC236}">
                <a16:creationId xmlns:a16="http://schemas.microsoft.com/office/drawing/2014/main" id="{FDA50417-7CC7-FCD8-DDF3-05DAFF72FC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2868" y="95637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5" name="Rectangle 11">
            <a:extLst>
              <a:ext uri="{FF2B5EF4-FFF2-40B4-BE49-F238E27FC236}">
                <a16:creationId xmlns:a16="http://schemas.microsoft.com/office/drawing/2014/main" id="{D05EBFDB-2734-3EA7-07BF-AF1B1118F7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2868" y="148977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9" name="Rectangle 13">
            <a:extLst>
              <a:ext uri="{FF2B5EF4-FFF2-40B4-BE49-F238E27FC236}">
                <a16:creationId xmlns:a16="http://schemas.microsoft.com/office/drawing/2014/main" id="{CCFFBC1C-5066-6BF3-F690-8DDEFFE811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20" name="Rectangle 21">
            <a:extLst>
              <a:ext uri="{FF2B5EF4-FFF2-40B4-BE49-F238E27FC236}">
                <a16:creationId xmlns:a16="http://schemas.microsoft.com/office/drawing/2014/main" id="{69373BB7-9D4F-B7C0-7576-9A4EF20683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35FF575-2798-10B5-61B9-6828A1ACFE35}"/>
              </a:ext>
            </a:extLst>
          </p:cNvPr>
          <p:cNvSpPr txBox="1"/>
          <p:nvPr/>
        </p:nvSpPr>
        <p:spPr>
          <a:xfrm>
            <a:off x="615202" y="685800"/>
            <a:ext cx="11351559" cy="36933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 Hematoxylin-eosin (HE) and immunohistochemistry staining in the tumor bed. The staining of the left lung tumor appears positive for pan-cytokeratin (PCK), Cytokeratin 7 (CK7), tumor protein 53(P53), neural cell adhesion molecule (CD56), and synaptophysin (Syn); negative for thyroid transcription factor-1 (TTF-1), cytokeratin 5/6 (CK5/6), tumor protein 40(P40), tumor protein 63(P63), anaplastic lymphoma kinase (ALK), Cluster of Differentiation 20 (CD20), Cluster of Differentiation 3 (CD3), and chromogranin A (Cg A), with the highest proliferative activity (Ki67 &gt; 80%) and the lowest programmed death-ligand 1 (PD-L1) &lt;1%. The microscopic image of the tumor: ×200 and scale bars: D = 100 µm. 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536864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73445CD8-BBE3-4C1A-1568-0D423612FE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829887"/>
            <a:ext cx="11430000" cy="5198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86164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2A8F13-987E-A38C-5966-9CFA772F8D2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26443F5-16C0-865A-B905-E13B9DD772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771" y="864523"/>
            <a:ext cx="11424458" cy="5128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6108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9</TotalTime>
  <Words>145</Words>
  <Application>Microsoft Office PowerPoint</Application>
  <PresentationFormat>宽屏</PresentationFormat>
  <Paragraphs>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hm5869@126.com</dc:creator>
  <cp:lastModifiedBy>红明 王</cp:lastModifiedBy>
  <cp:revision>45</cp:revision>
  <dcterms:created xsi:type="dcterms:W3CDTF">2023-01-08T09:37:05Z</dcterms:created>
  <dcterms:modified xsi:type="dcterms:W3CDTF">2024-10-10T13:55:55Z</dcterms:modified>
</cp:coreProperties>
</file>